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3921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8301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3579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5276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769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042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6967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5427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4833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9814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1892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F00F5BB6-2BB0-E94B-BA30-22531C2B648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457200"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58C79FE7-F3DE-5F4F-AB87-6BA31EB52CF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457200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17032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let_Av_resp_chr2_207026604.pn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504977"/>
            <a:ext cx="3019082" cy="3019082"/>
          </a:xfrm>
          <a:prstGeom prst="rect">
            <a:avLst/>
          </a:prstGeom>
        </p:spPr>
      </p:pic>
      <p:pic>
        <p:nvPicPr>
          <p:cNvPr id="3" name="Picture 2" descr="let_Av_resp_chr6_52860412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8534" y="504976"/>
            <a:ext cx="3019083" cy="3019083"/>
          </a:xfrm>
          <a:prstGeom prst="rect">
            <a:avLst/>
          </a:prstGeom>
        </p:spPr>
      </p:pic>
      <p:pic>
        <p:nvPicPr>
          <p:cNvPr id="4" name="Picture 3" descr="let_Av_resp_chr17_37009106.pn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7617" y="504977"/>
            <a:ext cx="3019082" cy="3019082"/>
          </a:xfrm>
          <a:prstGeom prst="rect">
            <a:avLst/>
          </a:prstGeom>
        </p:spPr>
      </p:pic>
      <p:pic>
        <p:nvPicPr>
          <p:cNvPr id="5" name="Picture 4" descr="let_Av_resp_hsa-miR-141-5p.pn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0546" y="3753093"/>
            <a:ext cx="3019080" cy="3019080"/>
          </a:xfrm>
          <a:prstGeom prst="rect">
            <a:avLst/>
          </a:prstGeom>
        </p:spPr>
      </p:pic>
      <p:pic>
        <p:nvPicPr>
          <p:cNvPr id="6" name="Picture 5" descr="let_Av_resp_hsa-miR-449a.pn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9083" y="3753093"/>
            <a:ext cx="3019080" cy="30190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-1" y="-7836"/>
            <a:ext cx="27841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19839" y="447826"/>
            <a:ext cx="1979405" cy="438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ORD51</a:t>
            </a:r>
          </a:p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39; fit </a:t>
            </a:r>
            <a:r>
              <a:rPr lang="en-US" sz="105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6.69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05939" y="447826"/>
            <a:ext cx="1979405" cy="438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N7SK</a:t>
            </a:r>
          </a:p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44; fit </a:t>
            </a:r>
            <a:r>
              <a:rPr lang="en-US" sz="105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2.21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692039" y="438301"/>
            <a:ext cx="1979405" cy="438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ORA21</a:t>
            </a:r>
          </a:p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19; fit </a:t>
            </a:r>
            <a:r>
              <a:rPr lang="en-US" sz="105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0258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00814" y="3696094"/>
            <a:ext cx="1979405" cy="438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a-miR-141-5p</a:t>
            </a:r>
          </a:p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82; fit </a:t>
            </a:r>
            <a:r>
              <a:rPr lang="en-US" sz="105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1.76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0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777389" y="3686569"/>
            <a:ext cx="1979405" cy="4385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a-miR-449a</a:t>
            </a:r>
          </a:p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92; fit </a:t>
            </a:r>
            <a:r>
              <a:rPr lang="en-US" sz="105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al</a:t>
            </a:r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6.52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5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02098" y="2048269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5.8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5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97148" y="2048269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028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407048" y="2048269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6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868919" y="2049752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4.8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397898" y="2064186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6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951325" y="2048269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01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965964" y="5307302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4.4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422092" y="5307302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028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937014" y="5297777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2.6 10</a:t>
            </a:r>
            <a:r>
              <a:rPr lang="en-US" sz="1050" b="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endParaRPr lang="en-US" sz="105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93964" y="5297777"/>
            <a:ext cx="90109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045 </a:t>
            </a:r>
          </a:p>
        </p:txBody>
      </p:sp>
    </p:spTree>
    <p:extLst>
      <p:ext uri="{BB962C8B-B14F-4D97-AF65-F5344CB8AC3E}">
        <p14:creationId xmlns:p14="http://schemas.microsoft.com/office/powerpoint/2010/main" val="3458215710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2</TotalTime>
  <Words>86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2_Office Them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Vaklavas</dc:creator>
  <cp:lastModifiedBy>Chris Vaklavas</cp:lastModifiedBy>
  <cp:revision>16</cp:revision>
  <dcterms:created xsi:type="dcterms:W3CDTF">2019-05-13T22:10:19Z</dcterms:created>
  <dcterms:modified xsi:type="dcterms:W3CDTF">2019-08-26T22:47:03Z</dcterms:modified>
</cp:coreProperties>
</file>